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FFF48D5-3E50-144B-B5D0-B0F6F2501514}" v="3" dt="2024-11-27T13:47:06.3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537"/>
  </p:normalViewPr>
  <p:slideViewPr>
    <p:cSldViewPr snapToGrid="0">
      <p:cViewPr varScale="1">
        <p:scale>
          <a:sx n="96" d="100"/>
          <a:sy n="96" d="100"/>
        </p:scale>
        <p:origin x="200" y="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suyuki.kaori.37s@st.kyoto-u.ac.jp" userId="770e1bc7-69e1-459b-847c-a3cd57a9a2ef" providerId="ADAL" clId="{0FFF48D5-3E50-144B-B5D0-B0F6F2501514}"/>
    <pc:docChg chg="modSld">
      <pc:chgData name="tsuyuki.kaori.37s@st.kyoto-u.ac.jp" userId="770e1bc7-69e1-459b-847c-a3cd57a9a2ef" providerId="ADAL" clId="{0FFF48D5-3E50-144B-B5D0-B0F6F2501514}" dt="2024-11-27T13:47:06.378" v="3" actId="14100"/>
      <pc:docMkLst>
        <pc:docMk/>
      </pc:docMkLst>
      <pc:sldChg chg="addSp delSp modSp">
        <pc:chgData name="tsuyuki.kaori.37s@st.kyoto-u.ac.jp" userId="770e1bc7-69e1-459b-847c-a3cd57a9a2ef" providerId="ADAL" clId="{0FFF48D5-3E50-144B-B5D0-B0F6F2501514}" dt="2024-11-27T13:47:06.378" v="3" actId="14100"/>
        <pc:sldMkLst>
          <pc:docMk/>
          <pc:sldMk cId="1120187956" sldId="257"/>
        </pc:sldMkLst>
        <pc:picChg chg="add mod">
          <ac:chgData name="tsuyuki.kaori.37s@st.kyoto-u.ac.jp" userId="770e1bc7-69e1-459b-847c-a3cd57a9a2ef" providerId="ADAL" clId="{0FFF48D5-3E50-144B-B5D0-B0F6F2501514}" dt="2024-11-27T13:47:06.378" v="3" actId="14100"/>
          <ac:picMkLst>
            <pc:docMk/>
            <pc:sldMk cId="1120187956" sldId="257"/>
            <ac:picMk id="2" creationId="{9ACD8E77-FF23-856A-6A23-5D747DDCBEA0}"/>
          </ac:picMkLst>
        </pc:picChg>
        <pc:picChg chg="del">
          <ac:chgData name="tsuyuki.kaori.37s@st.kyoto-u.ac.jp" userId="770e1bc7-69e1-459b-847c-a3cd57a9a2ef" providerId="ADAL" clId="{0FFF48D5-3E50-144B-B5D0-B0F6F2501514}" dt="2024-11-27T13:47:03.330" v="2" actId="478"/>
          <ac:picMkLst>
            <pc:docMk/>
            <pc:sldMk cId="1120187956" sldId="257"/>
            <ac:picMk id="1026" creationId="{1400DA39-7774-8632-6FB5-A0998CA90A21}"/>
          </ac:picMkLst>
        </pc:picChg>
      </pc:sldChg>
      <pc:sldChg chg="modSp mod">
        <pc:chgData name="tsuyuki.kaori.37s@st.kyoto-u.ac.jp" userId="770e1bc7-69e1-459b-847c-a3cd57a9a2ef" providerId="ADAL" clId="{0FFF48D5-3E50-144B-B5D0-B0F6F2501514}" dt="2024-11-27T08:35:25.987" v="0" actId="113"/>
        <pc:sldMkLst>
          <pc:docMk/>
          <pc:sldMk cId="3569497875" sldId="258"/>
        </pc:sldMkLst>
        <pc:spChg chg="mod">
          <ac:chgData name="tsuyuki.kaori.37s@st.kyoto-u.ac.jp" userId="770e1bc7-69e1-459b-847c-a3cd57a9a2ef" providerId="ADAL" clId="{0FFF48D5-3E50-144B-B5D0-B0F6F2501514}" dt="2024-11-27T08:35:25.987" v="0" actId="113"/>
          <ac:spMkLst>
            <pc:docMk/>
            <pc:sldMk cId="3569497875" sldId="258"/>
            <ac:spMk id="2" creationId="{4F7C8195-7A1B-DE13-13C2-C82E935F328C}"/>
          </ac:spMkLst>
        </pc:spChg>
      </pc:sldChg>
    </pc:docChg>
  </pc:docChgLst>
  <pc:docChgLst>
    <pc:chgData name="Lilitha Lwando Denga" userId="cf753dc2-8d57-448a-83ae-59c7b2e68c85" providerId="ADAL" clId="{7E220C5A-310A-4403-AECC-AE7D14B13F72}"/>
    <pc:docChg chg="modSld">
      <pc:chgData name="Lilitha Lwando Denga" userId="cf753dc2-8d57-448a-83ae-59c7b2e68c85" providerId="ADAL" clId="{7E220C5A-310A-4403-AECC-AE7D14B13F72}" dt="2024-11-25T10:59:32.599" v="3" actId="20577"/>
      <pc:docMkLst>
        <pc:docMk/>
      </pc:docMkLst>
      <pc:sldChg chg="modSp mod">
        <pc:chgData name="Lilitha Lwando Denga" userId="cf753dc2-8d57-448a-83ae-59c7b2e68c85" providerId="ADAL" clId="{7E220C5A-310A-4403-AECC-AE7D14B13F72}" dt="2024-11-25T10:59:32.599" v="3" actId="20577"/>
        <pc:sldMkLst>
          <pc:docMk/>
          <pc:sldMk cId="3569497875" sldId="258"/>
        </pc:sldMkLst>
        <pc:spChg chg="mod">
          <ac:chgData name="Lilitha Lwando Denga" userId="cf753dc2-8d57-448a-83ae-59c7b2e68c85" providerId="ADAL" clId="{7E220C5A-310A-4403-AECC-AE7D14B13F72}" dt="2024-11-25T10:59:32.599" v="3" actId="20577"/>
          <ac:spMkLst>
            <pc:docMk/>
            <pc:sldMk cId="3569497875" sldId="258"/>
            <ac:spMk id="2" creationId="{4F7C8195-7A1B-DE13-13C2-C82E935F328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788391-4D40-22B8-E4EE-F9D1CF4243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59E3059-2940-AAE1-4A37-8386722D49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F198DE-188B-030E-7EA5-97C928B9B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4093F1-E036-F7FD-1463-661CBA592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B9E683-8BF9-9427-BA9E-E4499A356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4754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597247-9E9C-EE30-7D77-C41019FC7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C60655-E945-3376-1026-38F5941782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7125F0-A1D3-7CDF-21CF-940D6E53F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1505C7-658E-3709-B42D-A294CBAE7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AF464A-A107-3738-A964-13AF52747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967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E1B3983-26CE-EA5E-5577-20E65EBC94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EE16E6A-5986-7FF8-EA95-97CC87F72B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5A72FA-C342-C7E7-0344-E46B8AA26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8FAAE4-1E1D-38C0-985F-7301A1290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12B673-9DAB-B5DE-234F-BD8738C0A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692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99355C-2C03-32FE-27A6-4C5D2D136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EA1116-B43C-A245-6D73-897FE5105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67D044-15D2-46B3-F48B-2DC80EDE0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F408D1-868D-10A8-ABC6-9B2D1AD6E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38AEFB-E75F-7A7B-FC35-6D5073563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364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A0179F-0192-7698-1986-712CE04DE4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D2EED3-3D6E-18F6-7F1A-7C18FE8D4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8A5A05-3534-C782-E2D4-39BC89758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0CFE0-F788-7E6C-158A-821035AF6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C7F5405-CEF1-7958-54D4-D199EEDAE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491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DD7A11-F3EC-0088-C393-65A499E66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A133C7-1CF6-938B-D34D-E91FC1F101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58FF432-CA35-6A6E-F542-DBDDA2F57A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F5E5F2-D86A-1F43-CCCA-162907CB0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105D77A-000F-B643-34AA-83C087EBE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05A191-EADB-B075-A221-22015CD6B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683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D9F05B-4912-1F52-9A05-9925FF69B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F5F6A15-4B03-2E99-2966-82116DA106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323C966-7B64-9FE0-91E5-E465D3159B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A8FC7CE-188E-1357-A509-B0032EF9A4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07E94C5-3A0E-90B2-F1C1-72697D7DB5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645B541-2375-B4CF-A682-4530C685F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1989592-ED50-DB33-7029-FC4B09C1C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3F0B1F7-7D9A-C77A-BA3F-A7F857148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723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098DA8-D292-F6AB-9AE0-1A41B4865F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FB7CF48-2F2C-A05E-24E6-62EB21F44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1A30FEA-288D-BE48-CB16-5B60244B2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5FB4676-4E25-9FDA-61E5-CC8DB89E4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580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664929D-ED64-4748-547B-23546F69E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2F8BFEE-E2F7-9A7F-BF93-625182F19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E5DD47E-D102-6ABF-6BBE-9A571F714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015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AB3B27-3F93-9104-DBE3-7040E32E8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D531B5-9B73-9854-1D50-D6ACA016EC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9B1D56C-EDBB-520A-79DD-2BFE0994F6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60A69F5-9C37-FD6E-A045-B7605E145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A56E53B-2145-9735-032F-5B7C2489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5FFA1A-D1F1-471D-F866-646A4A6D3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4479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2E3EF3-8258-EA0B-B808-7F77CE62C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F73D2FB-0D7B-C30B-314D-80995FBE3D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8945958-B668-9945-A687-2CC2F56E60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1B761BB-D947-C0E6-7744-C3CCCB928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7D19989-F9A1-5A3F-FEDC-EC3A956A6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345B31-83C1-9617-74D6-D27AFF022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843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1D9F883-882C-489E-BCFB-61541703F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9737DF-05B0-A4DA-A915-6A3AAFD60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519E8C-8B78-9667-ABD1-1036E2D307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900502-2A02-004D-8415-81A5B61E1982}" type="datetimeFigureOut">
              <a:rPr kumimoji="1" lang="ja-JP" altLang="en-US" smtClean="0"/>
              <a:t>2024/1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78206B-A7CD-7769-B285-F30D7CC02F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D0F3A72-1B3E-D69F-E3DA-44ED259364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A01458-B748-9345-BC3A-9D815EAD1A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055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09FDE6-5253-E48A-9B0A-E6148E97FB79}"/>
              </a:ext>
            </a:extLst>
          </p:cNvPr>
          <p:cNvSpPr txBox="1"/>
          <p:nvPr/>
        </p:nvSpPr>
        <p:spPr>
          <a:xfrm>
            <a:off x="3180678" y="6298328"/>
            <a:ext cx="5830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Number of Features</a:t>
            </a:r>
            <a:endParaRPr kumimoji="1" lang="ja-JP" altLang="en-US" b="1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9ACD8E77-FF23-856A-6A23-5D747DDCBE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6765" y="101798"/>
            <a:ext cx="8009835" cy="59497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20187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7C8195-7A1B-DE13-13C2-C82E935F328C}"/>
              </a:ext>
            </a:extLst>
          </p:cNvPr>
          <p:cNvSpPr txBox="1"/>
          <p:nvPr/>
        </p:nvSpPr>
        <p:spPr>
          <a:xfrm>
            <a:off x="537882" y="441064"/>
            <a:ext cx="11177196" cy="1678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earching for the optimal number of features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 obtain the highest AUC, the number of features was explored using recursive feature elimination from 443 features.</a:t>
            </a:r>
          </a:p>
          <a:p>
            <a:pPr algn="just">
              <a:lnSpc>
                <a:spcPct val="200000"/>
              </a:lnSpc>
            </a:pPr>
            <a:r>
              <a:rPr lang="en-US" altLang="ja-JP" kern="100" dirty="0"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AUC: </a:t>
            </a:r>
            <a:r>
              <a:rPr lang="en-US" altLang="ja-JP" b="1" kern="100" dirty="0"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kern="100" dirty="0"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he area under the receiver operating characteristic curve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9497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1</Words>
  <Application>Microsoft Macintosh PowerPoint</Application>
  <PresentationFormat>ワイド画面</PresentationFormat>
  <Paragraphs>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香 露木</dc:creator>
  <cp:lastModifiedBy>香 露木</cp:lastModifiedBy>
  <cp:revision>3</cp:revision>
  <dcterms:created xsi:type="dcterms:W3CDTF">2024-08-21T07:07:10Z</dcterms:created>
  <dcterms:modified xsi:type="dcterms:W3CDTF">2024-11-27T13:47:08Z</dcterms:modified>
</cp:coreProperties>
</file>